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3" r:id="rId2"/>
    <p:sldId id="294" r:id="rId3"/>
    <p:sldId id="295" r:id="rId4"/>
    <p:sldId id="296" r:id="rId5"/>
  </p:sldIdLst>
  <p:sldSz cx="9144000" cy="6858000" type="screen4x3"/>
  <p:notesSz cx="6742113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9945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9328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3362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3318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6377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6415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9605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4453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2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9645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4761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8F49A2-4C33-414F-8E71-2676548A2836}" type="datetimeFigureOut">
              <a:rPr lang="ko-KR" altLang="en-US" smtClean="0"/>
              <a:t>2018-1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D10E3-AB74-4AE1-8C30-C106E0D32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3579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F7CA3AF-B33D-4450-9237-9CEF2B8D987B}"/>
              </a:ext>
            </a:extLst>
          </p:cNvPr>
          <p:cNvSpPr txBox="1"/>
          <p:nvPr/>
        </p:nvSpPr>
        <p:spPr>
          <a:xfrm>
            <a:off x="1275128" y="645952"/>
            <a:ext cx="5970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upplementary Table</a:t>
            </a:r>
            <a:r>
              <a:rPr lang="ko-KR" altLang="en-US" dirty="0"/>
              <a:t> </a:t>
            </a:r>
            <a:r>
              <a:rPr lang="en-US" altLang="ko-KR" dirty="0"/>
              <a:t>S1.</a:t>
            </a:r>
            <a:r>
              <a:rPr lang="ko-KR" altLang="en-US" dirty="0"/>
              <a:t> </a:t>
            </a:r>
            <a:r>
              <a:rPr lang="en-US" altLang="ko-KR" dirty="0"/>
              <a:t>Primers</a:t>
            </a:r>
            <a:r>
              <a:rPr lang="ko-KR" altLang="en-US" dirty="0"/>
              <a:t> </a:t>
            </a:r>
            <a:r>
              <a:rPr lang="en-US" altLang="ko-KR" dirty="0"/>
              <a:t>for</a:t>
            </a:r>
            <a:r>
              <a:rPr lang="ko-KR" altLang="en-US" dirty="0"/>
              <a:t> </a:t>
            </a:r>
            <a:r>
              <a:rPr lang="en-US" altLang="ko-KR" dirty="0"/>
              <a:t>gene expression profiling</a:t>
            </a: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5051115D-F80D-48F7-B7D3-1679FAAB07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4890559"/>
              </p:ext>
            </p:extLst>
          </p:nvPr>
        </p:nvGraphicFramePr>
        <p:xfrm>
          <a:off x="1157682" y="1075475"/>
          <a:ext cx="6752741" cy="2667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35405">
                  <a:extLst>
                    <a:ext uri="{9D8B030D-6E8A-4147-A177-3AD203B41FA5}">
                      <a16:colId xmlns:a16="http://schemas.microsoft.com/office/drawing/2014/main" val="3413534516"/>
                    </a:ext>
                  </a:extLst>
                </a:gridCol>
                <a:gridCol w="3707104">
                  <a:extLst>
                    <a:ext uri="{9D8B030D-6E8A-4147-A177-3AD203B41FA5}">
                      <a16:colId xmlns:a16="http://schemas.microsoft.com/office/drawing/2014/main" val="2137149802"/>
                    </a:ext>
                  </a:extLst>
                </a:gridCol>
                <a:gridCol w="862851">
                  <a:extLst>
                    <a:ext uri="{9D8B030D-6E8A-4147-A177-3AD203B41FA5}">
                      <a16:colId xmlns:a16="http://schemas.microsoft.com/office/drawing/2014/main" val="1929754700"/>
                    </a:ext>
                  </a:extLst>
                </a:gridCol>
                <a:gridCol w="1247381">
                  <a:extLst>
                    <a:ext uri="{9D8B030D-6E8A-4147-A177-3AD203B41FA5}">
                      <a16:colId xmlns:a16="http://schemas.microsoft.com/office/drawing/2014/main" val="688346485"/>
                    </a:ext>
                  </a:extLst>
                </a:gridCol>
              </a:tblGrid>
              <a:tr h="27229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05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ko-KR" sz="105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05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ko-KR" sz="105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05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con</a:t>
                      </a:r>
                      <a:r>
                        <a:rPr lang="ko-KR" sz="105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ko-KR" sz="105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ko-KR" sz="105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ze</a:t>
                      </a:r>
                      <a:endParaRPr lang="ko-KR" sz="105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05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bank</a:t>
                      </a:r>
                      <a:endParaRPr lang="en-US" altLang="ko-KR" sz="105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05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5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ko-KR" sz="105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ession</a:t>
                      </a:r>
                      <a:r>
                        <a:rPr lang="ko-KR" sz="105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5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ko-KR" sz="105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tx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7402753"/>
                  </a:ext>
                </a:extLst>
              </a:tr>
              <a:tr h="27229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5’-CTCCAAACCTTTCCACCCC-3’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 5’-GATTCTTGGATACCACAGAGAATG-3’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 bp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0584.3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8035785"/>
                  </a:ext>
                </a:extLst>
              </a:tr>
              <a:tr h="26191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R1</a:t>
                      </a:r>
                      <a:endParaRPr lang="ko-KR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5’-ATCTGTCCCTGCCCTTCT-3’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 5’- AACACCATCCGCCATTTT-3’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 bp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0634.2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6082952"/>
                  </a:ext>
                </a:extLst>
              </a:tr>
              <a:tr h="26191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R2</a:t>
                      </a:r>
                      <a:endParaRPr lang="ko-KR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- 5’- ACATGGGCAACAATACAGCA-3’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- 5’-TGAGGACGACAGCAAAGATG-3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 </a:t>
                      </a:r>
                      <a:r>
                        <a:rPr lang="ko-KR" sz="110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1557.3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8294167"/>
                  </a:ext>
                </a:extLst>
              </a:tr>
              <a:tr h="26191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ko-KR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5’-GGGTGTGAACCATGAGAAGT-3’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 5’-GACTGTGGTCATGAGTCCT.-3’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 </a:t>
                      </a:r>
                      <a:r>
                        <a:rPr lang="ko-KR" sz="1100" b="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1289745.1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2577527"/>
                  </a:ext>
                </a:extLst>
              </a:tr>
              <a:tr h="26191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F143</a:t>
                      </a:r>
                      <a:endParaRPr lang="ko-KR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5</a:t>
                      </a: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CAGCATTCCATACTGCCTCA-3</a:t>
                      </a: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 5</a:t>
                      </a: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GAGATGGCTGTTCTCCAAGC-3</a:t>
                      </a:r>
                      <a:r>
                        <a:rPr lang="en-US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ko-KR" sz="1100" b="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 bp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3442.5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2193388"/>
                  </a:ext>
                </a:extLst>
              </a:tr>
              <a:tr h="26191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D206</a:t>
                      </a:r>
                      <a:endParaRPr lang="ko-KR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5</a:t>
                      </a: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IN" altLang="ko-KR" sz="1100" dirty="0">
                          <a:latin typeface="Arial" pitchFamily="34" charset="0"/>
                          <a:cs typeface="Arial" pitchFamily="34" charset="0"/>
                        </a:rPr>
                        <a:t>AGGGACGTGGCTGTGGATAA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ko-KR" sz="11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 5</a:t>
                      </a: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IN" altLang="ko-KR" sz="1100" dirty="0">
                          <a:latin typeface="Arial" pitchFamily="34" charset="0"/>
                          <a:cs typeface="Arial" pitchFamily="34" charset="0"/>
                        </a:rPr>
                        <a:t>TCCAAAACCCAGAAGACGCAT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6 </a:t>
                      </a:r>
                      <a:r>
                        <a:rPr lang="en-US" altLang="ko-KR" sz="1100" b="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p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M_002438.3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4592234"/>
                  </a:ext>
                </a:extLst>
              </a:tr>
              <a:tr h="26191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IL-6</a:t>
                      </a:r>
                      <a:endParaRPr lang="ko-KR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5</a:t>
                      </a: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GACCCAACCACAAATGCCA-3</a:t>
                      </a: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ko-KR" altLang="ko-KR" sz="11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 5</a:t>
                      </a: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altLang="ko-KR" sz="1100" b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GAGGTGCCCATGCTACATT-3</a:t>
                      </a:r>
                      <a:endParaRPr lang="ko-KR" alt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52 </a:t>
                      </a:r>
                      <a:r>
                        <a:rPr lang="en-US" altLang="ko-KR" sz="1100" b="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p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M_001318095.1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75" marR="63575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17568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7807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2A48119-93E8-4BCC-AF08-493606833E40}"/>
              </a:ext>
            </a:extLst>
          </p:cNvPr>
          <p:cNvSpPr txBox="1"/>
          <p:nvPr/>
        </p:nvSpPr>
        <p:spPr>
          <a:xfrm>
            <a:off x="1742429" y="238870"/>
            <a:ext cx="4993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upplementary Table</a:t>
            </a:r>
            <a:r>
              <a:rPr lang="ko-KR" altLang="en-US" dirty="0"/>
              <a:t> </a:t>
            </a:r>
            <a:r>
              <a:rPr lang="en-US" altLang="ko-KR" dirty="0"/>
              <a:t>S2.</a:t>
            </a:r>
            <a:r>
              <a:rPr lang="ko-KR" altLang="en-US" dirty="0"/>
              <a:t> </a:t>
            </a:r>
            <a:r>
              <a:rPr lang="en-US" altLang="ko-KR" dirty="0"/>
              <a:t>Tissue Information for IHC</a:t>
            </a: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A39D4537-6EC9-4A0D-9DB8-4063D26839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081" y="608202"/>
            <a:ext cx="4563072" cy="6136678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8EAC1E67-C501-450C-8BB1-A2FB7ABE5B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39153" y="608202"/>
            <a:ext cx="4306076" cy="46887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7991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7280394"/>
              </p:ext>
            </p:extLst>
          </p:nvPr>
        </p:nvGraphicFramePr>
        <p:xfrm>
          <a:off x="90107" y="298227"/>
          <a:ext cx="8981038" cy="6257857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948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071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55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9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0895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6071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3483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8467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0544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2110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432649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327804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310551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52585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11322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126026"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 staining                      -       (1)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S050002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very weak staining         +       (2)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ntibody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ZNF14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ZNF14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L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L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STAT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STAT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weak staining                 ++     (3)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ilu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/10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/10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/50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/50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/10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/10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Moderate staining          +++   (4)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Slide no.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1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1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0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0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0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0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Strong staining              ++++ (5)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ate of staining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8-06-201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8-06-201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1-07-2017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1-07-201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1-07-201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1-07-201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Sex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g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Orga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athology diagnosi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ra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Stag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N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ype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ZNF14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ZNF14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L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L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STAT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STAT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-[++]/ Cyto 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C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-[++]/ Cyto 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ucinous 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-[++]/ Cyto 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ucinous 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ucinous adenocarci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II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alignan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-[+++]/ Cyto 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bdominal cavity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mucinous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ive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sentery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of lymph node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ancrea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of lymph node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 of No.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-[++]/ Cyto 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mucinous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 with necrosi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247225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 (tumor necrosis)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26026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2A48119-93E8-4BCC-AF08-493606833E40}"/>
              </a:ext>
            </a:extLst>
          </p:cNvPr>
          <p:cNvSpPr txBox="1"/>
          <p:nvPr/>
        </p:nvSpPr>
        <p:spPr>
          <a:xfrm>
            <a:off x="1742429" y="-45788"/>
            <a:ext cx="56679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upplementary Table</a:t>
            </a:r>
            <a:r>
              <a:rPr lang="ko-KR" altLang="en-US" dirty="0"/>
              <a:t> </a:t>
            </a:r>
            <a:r>
              <a:rPr lang="en-US" altLang="ko-KR" dirty="0"/>
              <a:t>S3.</a:t>
            </a:r>
            <a:r>
              <a:rPr lang="ko-KR" altLang="en-US" dirty="0"/>
              <a:t> </a:t>
            </a:r>
            <a:r>
              <a:rPr lang="en-US" altLang="ko-KR" dirty="0" err="1"/>
              <a:t>Histopathological</a:t>
            </a:r>
            <a:r>
              <a:rPr lang="en-US" altLang="ko-KR" dirty="0"/>
              <a:t> Scoring  for IHC</a:t>
            </a:r>
          </a:p>
        </p:txBody>
      </p:sp>
    </p:spTree>
    <p:extLst>
      <p:ext uri="{BB962C8B-B14F-4D97-AF65-F5344CB8AC3E}">
        <p14:creationId xmlns:p14="http://schemas.microsoft.com/office/powerpoint/2010/main" val="18834290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332955"/>
              </p:ext>
            </p:extLst>
          </p:nvPr>
        </p:nvGraphicFramePr>
        <p:xfrm>
          <a:off x="120766" y="554807"/>
          <a:ext cx="8893837" cy="559428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0914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4328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4328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0912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7637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1917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7126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8467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1917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90113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449902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89781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38023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13918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36579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5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6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7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8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mucinous adeno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 </a:t>
                      </a:r>
                      <a:r>
                        <a:rPr lang="en-IN" sz="750" b="1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tumor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 </a:t>
                      </a:r>
                      <a:r>
                        <a:rPr lang="en-IN" sz="750" b="1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tumor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 </a:t>
                      </a:r>
                      <a:r>
                        <a:rPr lang="en-IN" sz="750" b="1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tumor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adenocarcinoma from colon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 </a:t>
                      </a:r>
                      <a:r>
                        <a:rPr lang="en-IN" sz="750" b="1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tumor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etastatic signet ring cell carcinoma from 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MET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551" marR="4551" marT="455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E1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alicular ade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E2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ubulovillous ade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enig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Tubulovillous</a:t>
                      </a:r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adenoma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enig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ubulovillous ade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enig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ubulovillous adenoma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Benig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yperplastic 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matous 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denomatous 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6379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N-[++]/ Cyto 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yperplastic 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E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Polyp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rohn's disease (chronic colitis)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rohn's disease (chronic colitis)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rohn's disease (chronic colitis)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rohn's diseas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uberculosis (fibrous tissue and smooth muscle)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TB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onic coliti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onic coliti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onic coliti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onic coliti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F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onic colitis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Inflammati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-[++]/ Cyto 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-[-]/ Cyto 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G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ancer adjacent 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AT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2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5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6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7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 tumor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8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9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974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10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++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[-]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ormal colonic tissue</a:t>
                      </a:r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IN" sz="75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75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IN" sz="75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72" marR="4872" marT="4872" marB="0" anchor="b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</a:tbl>
          </a:graphicData>
        </a:graphic>
      </p:graphicFrame>
      <p:sp>
        <p:nvSpPr>
          <p:cNvPr id="6" name="직사각형 3"/>
          <p:cNvSpPr/>
          <p:nvPr/>
        </p:nvSpPr>
        <p:spPr>
          <a:xfrm>
            <a:off x="3289160" y="102662"/>
            <a:ext cx="23261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 fontAlgn="b"/>
            <a:r>
              <a:rPr lang="en-US" altLang="ko-KR" sz="1200" b="1" dirty="0"/>
              <a:t>BS050002b-TISSUE MICROARRAY </a:t>
            </a:r>
            <a:endParaRPr lang="en-US" altLang="ko-KR" sz="1200" b="1" dirty="0">
              <a:solidFill>
                <a:srgbClr val="000000"/>
              </a:solidFill>
              <a:latin typeface="맑은 고딕" panose="020B05030200000200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929394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1454</Words>
  <Application>Microsoft Office PowerPoint</Application>
  <PresentationFormat>화면 슬라이드 쇼(4:3)</PresentationFormat>
  <Paragraphs>104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CC</dc:creator>
  <cp:lastModifiedBy>유혜진</cp:lastModifiedBy>
  <cp:revision>98</cp:revision>
  <cp:lastPrinted>2017-08-16T01:45:49Z</cp:lastPrinted>
  <dcterms:created xsi:type="dcterms:W3CDTF">2017-08-11T01:54:09Z</dcterms:created>
  <dcterms:modified xsi:type="dcterms:W3CDTF">2018-12-10T01:16:44Z</dcterms:modified>
</cp:coreProperties>
</file>